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392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912" y="3207741"/>
            <a:ext cx="3039912" cy="1361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55784" y="2870682"/>
            <a:ext cx="3301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C) </a:t>
            </a:r>
            <a:r>
              <a:rPr lang="en-US" altLang="zh-CN" i="1" dirty="0" smtClean="0">
                <a:latin typeface="Times New Roman" pitchFamily="18" charset="0"/>
                <a:cs typeface="Times New Roman" pitchFamily="18" charset="0"/>
              </a:rPr>
              <a:t>Pi5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aplotypes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340553" y="-62766"/>
            <a:ext cx="28881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) </a:t>
            </a:r>
            <a:r>
              <a:rPr lang="en-US" altLang="zh-CN" i="1" dirty="0" err="1" smtClean="0">
                <a:latin typeface="Times New Roman" pitchFamily="18" charset="0"/>
                <a:cs typeface="Times New Roman" pitchFamily="18" charset="0"/>
              </a:rPr>
              <a:t>Pik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 haplotypes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4427984" y="260648"/>
            <a:ext cx="2736304" cy="3168352"/>
            <a:chOff x="4427984" y="620688"/>
            <a:chExt cx="2736304" cy="3168352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27984" y="620688"/>
              <a:ext cx="2736304" cy="12961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4893513" y="1916831"/>
              <a:ext cx="430887" cy="11521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IRBLks-F5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355178" y="1916830"/>
              <a:ext cx="430887" cy="136815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IRBLkp-K60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93516" y="1916832"/>
              <a:ext cx="430887" cy="11521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225564" y="1950450"/>
              <a:ext cx="430887" cy="18385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err="1">
                  <a:latin typeface="Times New Roman" pitchFamily="18" charset="0"/>
                  <a:cs typeface="Times New Roman" pitchFamily="18" charset="0"/>
                </a:rPr>
                <a:t>Wuyugeng</a:t>
              </a:r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 No.2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700003" y="1988840"/>
              <a:ext cx="430887" cy="115781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err="1">
                  <a:latin typeface="Times New Roman" pitchFamily="18" charset="0"/>
                  <a:cs typeface="Times New Roman" pitchFamily="18" charset="0"/>
                </a:rPr>
                <a:t>Eyi</a:t>
              </a:r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 105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440632" y="-27384"/>
            <a:ext cx="2835224" cy="3067752"/>
            <a:chOff x="440632" y="284402"/>
            <a:chExt cx="2835224" cy="3067752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3976" y="620688"/>
              <a:ext cx="2520280" cy="1296144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440632" y="284402"/>
              <a:ext cx="2835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latin typeface="Times New Roman" pitchFamily="18" charset="0"/>
                  <a:cs typeface="Times New Roman" pitchFamily="18" charset="0"/>
                </a:rPr>
                <a:t>A) </a:t>
              </a:r>
              <a:r>
                <a:rPr lang="en-US" altLang="zh-CN" i="1" dirty="0" err="1" smtClean="0">
                  <a:latin typeface="Times New Roman" pitchFamily="18" charset="0"/>
                  <a:cs typeface="Times New Roman" pitchFamily="18" charset="0"/>
                </a:rPr>
                <a:t>Pib</a:t>
              </a:r>
              <a:r>
                <a:rPr lang="en-US" altLang="zh-CN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dirty="0" smtClean="0">
                  <a:latin typeface="Times New Roman" pitchFamily="18" charset="0"/>
                  <a:cs typeface="Times New Roman" pitchFamily="18" charset="0"/>
                </a:rPr>
                <a:t>haplotypes</a:t>
              </a:r>
              <a:endParaRPr lang="en-US" altLang="zh-CN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043608" y="1916832"/>
              <a:ext cx="430887" cy="8981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err="1" smtClean="0">
                  <a:latin typeface="Times New Roman" pitchFamily="18" charset="0"/>
                  <a:cs typeface="Times New Roman" pitchFamily="18" charset="0"/>
                </a:rPr>
                <a:t>IRBLb</a:t>
              </a:r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-B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587435" y="1916832"/>
              <a:ext cx="430887" cy="89812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smtClean="0">
                  <a:latin typeface="Times New Roman" pitchFamily="18" charset="0"/>
                  <a:cs typeface="Times New Roman" pitchFamily="18" charset="0"/>
                </a:rPr>
                <a:t>CO39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91491" y="1916832"/>
              <a:ext cx="430887" cy="143532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err="1">
                  <a:latin typeface="Times New Roman" pitchFamily="18" charset="0"/>
                  <a:cs typeface="Times New Roman" pitchFamily="18" charset="0"/>
                </a:rPr>
                <a:t>Qishanzhan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53156" y="1916832"/>
              <a:ext cx="430887" cy="122982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600" dirty="0" err="1">
                  <a:latin typeface="Times New Roman" pitchFamily="18" charset="0"/>
                  <a:cs typeface="Times New Roman" pitchFamily="18" charset="0"/>
                </a:rPr>
                <a:t>Zhefu</a:t>
              </a:r>
              <a:r>
                <a:rPr lang="en-US" altLang="zh-CN" sz="1600" dirty="0">
                  <a:latin typeface="Times New Roman" pitchFamily="18" charset="0"/>
                  <a:cs typeface="Times New Roman" pitchFamily="18" charset="0"/>
                </a:rPr>
                <a:t> 802</a:t>
              </a:r>
              <a:endParaRPr lang="zh-CN" alt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1075640" y="4590023"/>
            <a:ext cx="430887" cy="11489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RBLi-F5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26812" y="4590023"/>
            <a:ext cx="430887" cy="90674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RBL5-M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011744" y="4590023"/>
            <a:ext cx="430887" cy="79208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39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588969" y="4590023"/>
            <a:ext cx="430887" cy="178691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Wuyugeng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No.2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093025" y="4569691"/>
            <a:ext cx="430887" cy="153249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Eyi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105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438165" y="2852936"/>
            <a:ext cx="3301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D) </a:t>
            </a:r>
            <a:r>
              <a:rPr lang="en-US" altLang="zh-CN" i="1" dirty="0" smtClean="0">
                <a:latin typeface="Times New Roman" pitchFamily="18" charset="0"/>
                <a:cs typeface="Times New Roman" pitchFamily="18" charset="0"/>
              </a:rPr>
              <a:t>Pi2/9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haplotypes</a:t>
            </a:r>
            <a:endParaRPr lang="en-US" altLang="zh-CN" dirty="0" smtClean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20192" y="3207741"/>
            <a:ext cx="3045594" cy="14002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4965233" y="4590023"/>
            <a:ext cx="430887" cy="11489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RBLz5-CA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53729" y="4590023"/>
            <a:ext cx="430887" cy="102579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IRBLzt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T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189369" y="4590023"/>
            <a:ext cx="430887" cy="79208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39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829329" y="4590023"/>
            <a:ext cx="430887" cy="93459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RBL9-W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 rot="5400000">
            <a:off x="6323062" y="4959226"/>
            <a:ext cx="122097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Tianyou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998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 rot="5400000">
            <a:off x="6823024" y="4903714"/>
            <a:ext cx="10502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H you 518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4836" y="5865439"/>
            <a:ext cx="895071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Validation of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gene specific primers for PCR amplification. Different IRBLs and rice lines containing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ifferent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-gene haplotypes used in the analysis are indicated below each lane. The lane on the left refers to the DNA ladder. The PCR products are resolved in 1% of agarose gel. A)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Pib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haplotypes; B) </a:t>
            </a:r>
            <a:r>
              <a:rPr lang="en-US" altLang="zh-CN" sz="1600" i="1" dirty="0" err="1" smtClean="0">
                <a:latin typeface="Times New Roman" pitchFamily="18" charset="0"/>
                <a:cs typeface="Times New Roman" pitchFamily="18" charset="0"/>
              </a:rPr>
              <a:t>Pik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haplotypes; C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Pi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haplotypes; D)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Pi2/9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haplotypes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40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18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Zhou, Bo (FAORAP)</cp:lastModifiedBy>
  <cp:revision>5</cp:revision>
  <dcterms:modified xsi:type="dcterms:W3CDTF">2019-12-14T15:58:34Z</dcterms:modified>
</cp:coreProperties>
</file>